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0" r:id="rId2"/>
  </p:sldIdLst>
  <p:sldSz cx="6858000" cy="9144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64">
          <p15:clr>
            <a:srgbClr val="A4A3A4"/>
          </p15:clr>
        </p15:guide>
        <p15:guide id="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99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45" d="100"/>
          <a:sy n="45" d="100"/>
        </p:scale>
        <p:origin x="2148" y="40"/>
      </p:cViewPr>
      <p:guideLst>
        <p:guide orient="horz" pos="2064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宇治　利樹" userId="7d873538-4702-45d0-94ca-7f299c9d914c" providerId="ADAL" clId="{FF124050-A8B8-4278-BD72-D45BF0874056}"/>
    <pc:docChg chg="undo custSel addSld delSld modSld">
      <pc:chgData name="宇治　利樹" userId="7d873538-4702-45d0-94ca-7f299c9d914c" providerId="ADAL" clId="{FF124050-A8B8-4278-BD72-D45BF0874056}" dt="2024-01-26T09:18:49.034" v="9" actId="14100"/>
      <pc:docMkLst>
        <pc:docMk/>
      </pc:docMkLst>
      <pc:sldChg chg="del">
        <pc:chgData name="宇治　利樹" userId="7d873538-4702-45d0-94ca-7f299c9d914c" providerId="ADAL" clId="{FF124050-A8B8-4278-BD72-D45BF0874056}" dt="2024-01-26T09:18:37.298" v="3" actId="47"/>
        <pc:sldMkLst>
          <pc:docMk/>
          <pc:sldMk cId="3820649270" sldId="270"/>
        </pc:sldMkLst>
      </pc:sldChg>
      <pc:sldChg chg="del">
        <pc:chgData name="宇治　利樹" userId="7d873538-4702-45d0-94ca-7f299c9d914c" providerId="ADAL" clId="{FF124050-A8B8-4278-BD72-D45BF0874056}" dt="2024-01-26T09:18:27.941" v="0" actId="47"/>
        <pc:sldMkLst>
          <pc:docMk/>
          <pc:sldMk cId="749546706" sldId="275"/>
        </pc:sldMkLst>
      </pc:sldChg>
      <pc:sldChg chg="modSp add del mod">
        <pc:chgData name="宇治　利樹" userId="7d873538-4702-45d0-94ca-7f299c9d914c" providerId="ADAL" clId="{FF124050-A8B8-4278-BD72-D45BF0874056}" dt="2024-01-26T09:18:49.034" v="9" actId="14100"/>
        <pc:sldMkLst>
          <pc:docMk/>
          <pc:sldMk cId="4008559439" sldId="280"/>
        </pc:sldMkLst>
        <pc:spChg chg="mod">
          <ac:chgData name="宇治　利樹" userId="7d873538-4702-45d0-94ca-7f299c9d914c" providerId="ADAL" clId="{FF124050-A8B8-4278-BD72-D45BF0874056}" dt="2024-01-26T09:18:49.034" v="9" actId="14100"/>
          <ac:spMkLst>
            <pc:docMk/>
            <pc:sldMk cId="4008559439" sldId="280"/>
            <ac:spMk id="2" creationId="{F397CCC0-C1C8-6051-F7F1-671F3E89658F}"/>
          </ac:spMkLst>
        </pc:spChg>
      </pc:sldChg>
      <pc:sldChg chg="del">
        <pc:chgData name="宇治　利樹" userId="7d873538-4702-45d0-94ca-7f299c9d914c" providerId="ADAL" clId="{FF124050-A8B8-4278-BD72-D45BF0874056}" dt="2024-01-26T09:18:38.781" v="4" actId="47"/>
        <pc:sldMkLst>
          <pc:docMk/>
          <pc:sldMk cId="4148999680" sldId="282"/>
        </pc:sldMkLst>
      </pc:sldChg>
    </pc:docChg>
  </pc:docChgLst>
  <pc:docChgLst>
    <pc:chgData name="宇治　利樹" userId="7d873538-4702-45d0-94ca-7f299c9d914c" providerId="ADAL" clId="{5E652C12-93F8-452B-94A2-F5C86EBC550D}"/>
    <pc:docChg chg="custSel modSld">
      <pc:chgData name="宇治　利樹" userId="7d873538-4702-45d0-94ca-7f299c9d914c" providerId="ADAL" clId="{5E652C12-93F8-452B-94A2-F5C86EBC550D}" dt="2024-02-15T23:52:42.312" v="5" actId="1076"/>
      <pc:docMkLst>
        <pc:docMk/>
      </pc:docMkLst>
      <pc:sldChg chg="addSp delSp modSp mod">
        <pc:chgData name="宇治　利樹" userId="7d873538-4702-45d0-94ca-7f299c9d914c" providerId="ADAL" clId="{5E652C12-93F8-452B-94A2-F5C86EBC550D}" dt="2024-02-15T23:52:42.312" v="5" actId="1076"/>
        <pc:sldMkLst>
          <pc:docMk/>
          <pc:sldMk cId="4008559439" sldId="280"/>
        </pc:sldMkLst>
        <pc:spChg chg="del">
          <ac:chgData name="宇治　利樹" userId="7d873538-4702-45d0-94ca-7f299c9d914c" providerId="ADAL" clId="{5E652C12-93F8-452B-94A2-F5C86EBC550D}" dt="2024-02-15T23:52:39.630" v="4" actId="478"/>
          <ac:spMkLst>
            <pc:docMk/>
            <pc:sldMk cId="4008559439" sldId="280"/>
            <ac:spMk id="2" creationId="{F397CCC0-C1C8-6051-F7F1-671F3E89658F}"/>
          </ac:spMkLst>
        </pc:spChg>
        <pc:spChg chg="add mod">
          <ac:chgData name="宇治　利樹" userId="7d873538-4702-45d0-94ca-7f299c9d914c" providerId="ADAL" clId="{5E652C12-93F8-452B-94A2-F5C86EBC550D}" dt="2024-02-15T23:52:42.312" v="5" actId="1076"/>
          <ac:spMkLst>
            <pc:docMk/>
            <pc:sldMk cId="4008559439" sldId="280"/>
            <ac:spMk id="5" creationId="{13ADCE38-8935-CE34-4856-336B6048FEA6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97EA64-8EB2-484D-B925-678DD0174107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9FCFDC-724D-41A5-B5C1-F02459AF79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46702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8321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668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7682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0991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6040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419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4587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9601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7406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9601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4491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41EAC-4273-4CB1-ABC8-49CB7A4AC31A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9863D4-B134-4105-9DC9-2F4B9DFCE4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997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A3018DAF-0919-44B5-77E9-E3674C5918CA}"/>
              </a:ext>
            </a:extLst>
          </p:cNvPr>
          <p:cNvSpPr/>
          <p:nvPr/>
        </p:nvSpPr>
        <p:spPr>
          <a:xfrm>
            <a:off x="1324886" y="2920938"/>
            <a:ext cx="4176000" cy="152446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0109A6EA-B3AF-732E-4AE1-C3A85FEC474A}"/>
              </a:ext>
            </a:extLst>
          </p:cNvPr>
          <p:cNvSpPr/>
          <p:nvPr/>
        </p:nvSpPr>
        <p:spPr>
          <a:xfrm>
            <a:off x="960758" y="2752503"/>
            <a:ext cx="45557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C09157EA-E3FC-9E81-7885-2CABE932CA8A}"/>
              </a:ext>
            </a:extLst>
          </p:cNvPr>
          <p:cNvSpPr/>
          <p:nvPr/>
        </p:nvSpPr>
        <p:spPr>
          <a:xfrm>
            <a:off x="5429342" y="2769438"/>
            <a:ext cx="44114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63CED5FF-840D-EBC3-741E-C4806F9364EC}"/>
              </a:ext>
            </a:extLst>
          </p:cNvPr>
          <p:cNvSpPr/>
          <p:nvPr/>
        </p:nvSpPr>
        <p:spPr>
          <a:xfrm>
            <a:off x="1690543" y="3110393"/>
            <a:ext cx="382668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8                                                             406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7B287ED-0BC1-5CD4-726A-3FA75F2BA8CD}"/>
              </a:ext>
            </a:extLst>
          </p:cNvPr>
          <p:cNvSpPr txBox="1"/>
          <p:nvPr/>
        </p:nvSpPr>
        <p:spPr>
          <a:xfrm>
            <a:off x="3028906" y="3157068"/>
            <a:ext cx="172819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ptidase S8</a:t>
            </a: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26CEFAE8-309F-EBA0-F544-78A3595C211C}"/>
              </a:ext>
            </a:extLst>
          </p:cNvPr>
          <p:cNvSpPr/>
          <p:nvPr/>
        </p:nvSpPr>
        <p:spPr>
          <a:xfrm>
            <a:off x="1972958" y="2772856"/>
            <a:ext cx="3312367" cy="400110"/>
          </a:xfrm>
          <a:prstGeom prst="rect">
            <a:avLst/>
          </a:prstGeom>
          <a:solidFill>
            <a:srgbClr val="0070C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970DC216-53F6-5387-906D-3D2C92FF8855}"/>
              </a:ext>
            </a:extLst>
          </p:cNvPr>
          <p:cNvCxnSpPr>
            <a:cxnSpLocks/>
          </p:cNvCxnSpPr>
          <p:nvPr/>
        </p:nvCxnSpPr>
        <p:spPr>
          <a:xfrm rot="10800000">
            <a:off x="2188982" y="2552390"/>
            <a:ext cx="0" cy="222848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0E26C326-4437-2C71-A541-A54DAD5983A1}"/>
              </a:ext>
            </a:extLst>
          </p:cNvPr>
          <p:cNvSpPr/>
          <p:nvPr/>
        </p:nvSpPr>
        <p:spPr>
          <a:xfrm>
            <a:off x="1873546" y="2267744"/>
            <a:ext cx="57714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11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D5036283-FBE2-5B25-FB11-45BAEAF1F641}"/>
              </a:ext>
            </a:extLst>
          </p:cNvPr>
          <p:cNvCxnSpPr>
            <a:cxnSpLocks/>
          </p:cNvCxnSpPr>
          <p:nvPr/>
        </p:nvCxnSpPr>
        <p:spPr>
          <a:xfrm rot="10800000">
            <a:off x="2712645" y="2549904"/>
            <a:ext cx="0" cy="222848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6058226D-688D-3222-EB3A-7937DEFA4F09}"/>
              </a:ext>
            </a:extLst>
          </p:cNvPr>
          <p:cNvSpPr/>
          <p:nvPr/>
        </p:nvSpPr>
        <p:spPr>
          <a:xfrm>
            <a:off x="2445092" y="2267744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151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9859EF8B-D972-7D32-9BB9-45232E2A4356}"/>
              </a:ext>
            </a:extLst>
          </p:cNvPr>
          <p:cNvCxnSpPr>
            <a:cxnSpLocks/>
          </p:cNvCxnSpPr>
          <p:nvPr/>
        </p:nvCxnSpPr>
        <p:spPr>
          <a:xfrm rot="10800000">
            <a:off x="4243093" y="2535952"/>
            <a:ext cx="0" cy="222848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F60BB448-909F-DABE-A77B-36FA7824C39C}"/>
              </a:ext>
            </a:extLst>
          </p:cNvPr>
          <p:cNvSpPr/>
          <p:nvPr/>
        </p:nvSpPr>
        <p:spPr>
          <a:xfrm>
            <a:off x="3917174" y="2267744"/>
            <a:ext cx="5533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3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40FAA29-E3D8-2668-81F5-545F0033DD70}"/>
              </a:ext>
            </a:extLst>
          </p:cNvPr>
          <p:cNvSpPr txBox="1"/>
          <p:nvPr/>
        </p:nvSpPr>
        <p:spPr>
          <a:xfrm>
            <a:off x="2179164" y="3518383"/>
            <a:ext cx="30858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8 family peptidase (g3839)</a:t>
            </a: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0E57D658-C748-26EE-E7C0-8CCAF8BDA2C2}"/>
              </a:ext>
            </a:extLst>
          </p:cNvPr>
          <p:cNvSpPr/>
          <p:nvPr/>
        </p:nvSpPr>
        <p:spPr>
          <a:xfrm>
            <a:off x="1305248" y="970054"/>
            <a:ext cx="4356000" cy="144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C5DC5DBB-3CFD-AC9A-A54A-FA97BFE9EFA6}"/>
              </a:ext>
            </a:extLst>
          </p:cNvPr>
          <p:cNvSpPr/>
          <p:nvPr/>
        </p:nvSpPr>
        <p:spPr>
          <a:xfrm>
            <a:off x="957202" y="789950"/>
            <a:ext cx="45557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B1CC36AB-2055-6024-38D1-A1E37273CF3F}"/>
              </a:ext>
            </a:extLst>
          </p:cNvPr>
          <p:cNvSpPr/>
          <p:nvPr/>
        </p:nvSpPr>
        <p:spPr>
          <a:xfrm>
            <a:off x="5561299" y="803386"/>
            <a:ext cx="44114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1D089913-CEE9-553D-CDE8-3358404AC0C3}"/>
              </a:ext>
            </a:extLst>
          </p:cNvPr>
          <p:cNvSpPr/>
          <p:nvPr/>
        </p:nvSpPr>
        <p:spPr>
          <a:xfrm>
            <a:off x="2402045" y="1159509"/>
            <a:ext cx="300595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8                                           494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3B5CBF9C-A013-320F-7B92-D381DB254530}"/>
              </a:ext>
            </a:extLst>
          </p:cNvPr>
          <p:cNvSpPr txBox="1"/>
          <p:nvPr/>
        </p:nvSpPr>
        <p:spPr>
          <a:xfrm>
            <a:off x="3356992" y="1204341"/>
            <a:ext cx="172819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ptidase S1</a:t>
            </a: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2CDCF59B-303C-0A4F-2DA5-25D932BB01B1}"/>
              </a:ext>
            </a:extLst>
          </p:cNvPr>
          <p:cNvSpPr/>
          <p:nvPr/>
        </p:nvSpPr>
        <p:spPr>
          <a:xfrm>
            <a:off x="2852938" y="843054"/>
            <a:ext cx="2190974" cy="379028"/>
          </a:xfrm>
          <a:prstGeom prst="rect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E41F16AC-DA64-640F-5F33-8C2C9831E214}"/>
              </a:ext>
            </a:extLst>
          </p:cNvPr>
          <p:cNvCxnSpPr>
            <a:cxnSpLocks/>
          </p:cNvCxnSpPr>
          <p:nvPr/>
        </p:nvCxnSpPr>
        <p:spPr>
          <a:xfrm rot="10800000">
            <a:off x="3068960" y="604736"/>
            <a:ext cx="0" cy="222848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035D4270-1B48-E6F1-9315-1C80C09EBB89}"/>
              </a:ext>
            </a:extLst>
          </p:cNvPr>
          <p:cNvSpPr/>
          <p:nvPr/>
        </p:nvSpPr>
        <p:spPr>
          <a:xfrm>
            <a:off x="2708920" y="303783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26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3F20DF4A-167D-3086-55AD-D9012B466F20}"/>
              </a:ext>
            </a:extLst>
          </p:cNvPr>
          <p:cNvCxnSpPr>
            <a:cxnSpLocks/>
          </p:cNvCxnSpPr>
          <p:nvPr/>
        </p:nvCxnSpPr>
        <p:spPr>
          <a:xfrm rot="10800000">
            <a:off x="3616795" y="602250"/>
            <a:ext cx="0" cy="222848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BF5C588D-F0B0-A559-CC40-617F2CE261D2}"/>
              </a:ext>
            </a:extLst>
          </p:cNvPr>
          <p:cNvSpPr/>
          <p:nvPr/>
        </p:nvSpPr>
        <p:spPr>
          <a:xfrm>
            <a:off x="3349242" y="303783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31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線矢印コネクタ 41">
            <a:extLst>
              <a:ext uri="{FF2B5EF4-FFF2-40B4-BE49-F238E27FC236}">
                <a16:creationId xmlns:a16="http://schemas.microsoft.com/office/drawing/2014/main" id="{7F6E420D-DCB0-BACB-D226-99EF4C2982D2}"/>
              </a:ext>
            </a:extLst>
          </p:cNvPr>
          <p:cNvCxnSpPr>
            <a:cxnSpLocks/>
          </p:cNvCxnSpPr>
          <p:nvPr/>
        </p:nvCxnSpPr>
        <p:spPr>
          <a:xfrm rot="10800000">
            <a:off x="4797152" y="588298"/>
            <a:ext cx="0" cy="222848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0112ACA5-3766-EBD6-7F4F-C40A555E861B}"/>
              </a:ext>
            </a:extLst>
          </p:cNvPr>
          <p:cNvSpPr/>
          <p:nvPr/>
        </p:nvSpPr>
        <p:spPr>
          <a:xfrm>
            <a:off x="4509120" y="303783"/>
            <a:ext cx="5533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3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7D6D96B-9CF2-6AC0-E43E-D2A50AAA52BF}"/>
              </a:ext>
            </a:extLst>
          </p:cNvPr>
          <p:cNvSpPr txBox="1"/>
          <p:nvPr/>
        </p:nvSpPr>
        <p:spPr>
          <a:xfrm>
            <a:off x="1782835" y="1548582"/>
            <a:ext cx="37751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ypsin-like serine protease (g8207)</a:t>
            </a:r>
          </a:p>
        </p:txBody>
      </p: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E10128C5-B145-163D-5130-109C27C4F570}"/>
              </a:ext>
            </a:extLst>
          </p:cNvPr>
          <p:cNvSpPr/>
          <p:nvPr/>
        </p:nvSpPr>
        <p:spPr>
          <a:xfrm>
            <a:off x="764704" y="4925164"/>
            <a:ext cx="5652000" cy="152446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105D07D9-EA6E-A043-E9A3-BED771A39762}"/>
              </a:ext>
            </a:extLst>
          </p:cNvPr>
          <p:cNvSpPr/>
          <p:nvPr/>
        </p:nvSpPr>
        <p:spPr>
          <a:xfrm>
            <a:off x="404664" y="4756729"/>
            <a:ext cx="45557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ED9E6A71-AB6A-C60B-1718-D6A26451739E}"/>
              </a:ext>
            </a:extLst>
          </p:cNvPr>
          <p:cNvSpPr/>
          <p:nvPr/>
        </p:nvSpPr>
        <p:spPr>
          <a:xfrm>
            <a:off x="6309320" y="4773664"/>
            <a:ext cx="44114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2421E770-2B7A-FD58-D8D0-CA5E6BB324C9}"/>
              </a:ext>
            </a:extLst>
          </p:cNvPr>
          <p:cNvSpPr/>
          <p:nvPr/>
        </p:nvSpPr>
        <p:spPr>
          <a:xfrm>
            <a:off x="980728" y="5114619"/>
            <a:ext cx="526297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                                                                                          729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90DDEA82-C066-992E-542D-5126E105A6B4}"/>
              </a:ext>
            </a:extLst>
          </p:cNvPr>
          <p:cNvSpPr txBox="1"/>
          <p:nvPr/>
        </p:nvSpPr>
        <p:spPr>
          <a:xfrm>
            <a:off x="2996952" y="5161294"/>
            <a:ext cx="172819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ptidase M13</a:t>
            </a: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94256536-5FC9-1EA6-A0B0-E75B30F58BBE}"/>
              </a:ext>
            </a:extLst>
          </p:cNvPr>
          <p:cNvSpPr/>
          <p:nvPr/>
        </p:nvSpPr>
        <p:spPr>
          <a:xfrm>
            <a:off x="1196752" y="4777082"/>
            <a:ext cx="4896000" cy="400110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線矢印コネクタ 54">
            <a:extLst>
              <a:ext uri="{FF2B5EF4-FFF2-40B4-BE49-F238E27FC236}">
                <a16:creationId xmlns:a16="http://schemas.microsoft.com/office/drawing/2014/main" id="{0F2027DB-51CA-C0EE-FC71-20BD40F9CD0F}"/>
              </a:ext>
            </a:extLst>
          </p:cNvPr>
          <p:cNvCxnSpPr>
            <a:cxnSpLocks/>
          </p:cNvCxnSpPr>
          <p:nvPr/>
        </p:nvCxnSpPr>
        <p:spPr>
          <a:xfrm rot="10800000">
            <a:off x="4992697" y="4554130"/>
            <a:ext cx="0" cy="222848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B5EA4089-11AE-53FC-396D-A8D307D2C447}"/>
              </a:ext>
            </a:extLst>
          </p:cNvPr>
          <p:cNvSpPr/>
          <p:nvPr/>
        </p:nvSpPr>
        <p:spPr>
          <a:xfrm>
            <a:off x="4375573" y="4261708"/>
            <a:ext cx="1141659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559, E560, 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56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395C9AE1-AE1E-C254-E0C4-FCD789FE4180}"/>
              </a:ext>
            </a:extLst>
          </p:cNvPr>
          <p:cNvSpPr txBox="1"/>
          <p:nvPr/>
        </p:nvSpPr>
        <p:spPr>
          <a:xfrm>
            <a:off x="2199134" y="5522609"/>
            <a:ext cx="42542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prilysi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ike protease(g5197)</a:t>
            </a:r>
          </a:p>
        </p:txBody>
      </p:sp>
      <p:cxnSp>
        <p:nvCxnSpPr>
          <p:cNvPr id="62" name="直線矢印コネクタ 61">
            <a:extLst>
              <a:ext uri="{FF2B5EF4-FFF2-40B4-BE49-F238E27FC236}">
                <a16:creationId xmlns:a16="http://schemas.microsoft.com/office/drawing/2014/main" id="{8C111DD8-84F9-D989-67F0-D3D14D8ADB07}"/>
              </a:ext>
            </a:extLst>
          </p:cNvPr>
          <p:cNvCxnSpPr>
            <a:cxnSpLocks/>
          </p:cNvCxnSpPr>
          <p:nvPr/>
        </p:nvCxnSpPr>
        <p:spPr>
          <a:xfrm rot="10800000">
            <a:off x="5784785" y="4566128"/>
            <a:ext cx="0" cy="222848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1F4FF72C-23E4-4599-4079-F46C24E1F18F}"/>
              </a:ext>
            </a:extLst>
          </p:cNvPr>
          <p:cNvSpPr/>
          <p:nvPr/>
        </p:nvSpPr>
        <p:spPr>
          <a:xfrm>
            <a:off x="5373216" y="4258351"/>
            <a:ext cx="105189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624, D628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3ADCE38-8935-CE34-4856-336B6048FEA6}"/>
              </a:ext>
            </a:extLst>
          </p:cNvPr>
          <p:cNvSpPr txBox="1"/>
          <p:nvPr/>
        </p:nvSpPr>
        <p:spPr>
          <a:xfrm>
            <a:off x="291597" y="6605320"/>
            <a:ext cx="6338014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Figure S1</a:t>
            </a:r>
          </a:p>
          <a:p>
            <a:r>
              <a:rPr lang="en-US" altLang="ja-JP" dirty="0"/>
              <a:t>Schematic representations of </a:t>
            </a:r>
            <a:r>
              <a:rPr lang="en-US" altLang="ja-JP" dirty="0" err="1"/>
              <a:t>Pyropia</a:t>
            </a:r>
            <a:r>
              <a:rPr lang="en-US" altLang="ja-JP" dirty="0"/>
              <a:t> </a:t>
            </a:r>
            <a:r>
              <a:rPr lang="en-US" altLang="ja-JP" dirty="0" err="1"/>
              <a:t>yezoensis</a:t>
            </a:r>
            <a:r>
              <a:rPr lang="en-US" altLang="ja-JP" dirty="0"/>
              <a:t> proteases in response to 1-aminocyclopropane-1-carboxylic acid (ACC). </a:t>
            </a:r>
          </a:p>
          <a:p>
            <a:r>
              <a:rPr lang="en-US" altLang="ja-JP" dirty="0"/>
              <a:t>Conserved domains were confirmed using the “</a:t>
            </a:r>
            <a:r>
              <a:rPr lang="en-US" altLang="ja-JP" dirty="0" err="1"/>
              <a:t>ScanProsite</a:t>
            </a:r>
            <a:r>
              <a:rPr lang="en-US" altLang="ja-JP" dirty="0"/>
              <a:t>” feature under </a:t>
            </a:r>
            <a:r>
              <a:rPr lang="en-US" altLang="ja-JP" dirty="0" err="1"/>
              <a:t>ExPASy</a:t>
            </a:r>
            <a:r>
              <a:rPr lang="en-US" altLang="ja-JP" dirty="0"/>
              <a:t> (http://tw.expasy.org/tools/scanprosite/). Arrows indicate conserved amino acids. Numbers correspond to amino acid positions from the ﬁrst methionine residue.</a:t>
            </a:r>
          </a:p>
        </p:txBody>
      </p:sp>
    </p:spTree>
    <p:extLst>
      <p:ext uri="{BB962C8B-B14F-4D97-AF65-F5344CB8AC3E}">
        <p14:creationId xmlns:p14="http://schemas.microsoft.com/office/powerpoint/2010/main" val="4008559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95</TotalTime>
  <Words>111</Words>
  <Application>Microsoft Office PowerPoint</Application>
  <PresentationFormat>画面に合わせる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uji</dc:creator>
  <cp:lastModifiedBy>宇治　利樹</cp:lastModifiedBy>
  <cp:revision>351</cp:revision>
  <cp:lastPrinted>2019-09-02T01:08:50Z</cp:lastPrinted>
  <dcterms:created xsi:type="dcterms:W3CDTF">2015-11-12T03:14:20Z</dcterms:created>
  <dcterms:modified xsi:type="dcterms:W3CDTF">2024-02-15T23:52:44Z</dcterms:modified>
</cp:coreProperties>
</file>